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95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65" userDrawn="1">
          <p15:clr>
            <a:srgbClr val="A4A3A4"/>
          </p15:clr>
        </p15:guide>
        <p15:guide id="2" pos="31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800" autoAdjust="0"/>
    <p:restoredTop sz="94643" autoAdjust="0"/>
  </p:normalViewPr>
  <p:slideViewPr>
    <p:cSldViewPr snapToGrid="0">
      <p:cViewPr varScale="1">
        <p:scale>
          <a:sx n="97" d="100"/>
          <a:sy n="97" d="100"/>
        </p:scale>
        <p:origin x="1458" y="84"/>
      </p:cViewPr>
      <p:guideLst>
        <p:guide orient="horz" pos="1865"/>
        <p:guide pos="316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OHI-FSI\VOLI\Home\LARG\MCPHERSON\Sebastien\Results%202018\OCT%201%202018%20SE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mmary of 3'!$I$54</c:f>
              <c:strCache>
                <c:ptCount val="1"/>
                <c:pt idx="0">
                  <c:v>IL6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ummary of 3'!$K$55:$K$66</c:f>
                <c:numCache>
                  <c:formatCode>General</c:formatCode>
                  <c:ptCount val="12"/>
                  <c:pt idx="0">
                    <c:v>0.38683572691789442</c:v>
                  </c:pt>
                  <c:pt idx="1">
                    <c:v>0.1637575278864194</c:v>
                  </c:pt>
                  <c:pt idx="2">
                    <c:v>0.23293269491950661</c:v>
                  </c:pt>
                  <c:pt idx="3">
                    <c:v>0.25848551106004719</c:v>
                  </c:pt>
                  <c:pt idx="4">
                    <c:v>0.16038701517168941</c:v>
                  </c:pt>
                  <c:pt idx="5">
                    <c:v>0.13287706947858635</c:v>
                  </c:pt>
                  <c:pt idx="6">
                    <c:v>0.17203765264582366</c:v>
                  </c:pt>
                  <c:pt idx="7">
                    <c:v>0.33310363174139285</c:v>
                  </c:pt>
                  <c:pt idx="8">
                    <c:v>0.3683048433048432</c:v>
                  </c:pt>
                  <c:pt idx="9">
                    <c:v>9.7079772079772031E-2</c:v>
                  </c:pt>
                  <c:pt idx="10">
                    <c:v>0</c:v>
                  </c:pt>
                  <c:pt idx="11">
                    <c:v>0.15111417296006036</c:v>
                  </c:pt>
                </c:numCache>
              </c:numRef>
            </c:plus>
            <c:minus>
              <c:numRef>
                <c:f>'summary of 3'!$K$55:$K$66</c:f>
                <c:numCache>
                  <c:formatCode>General</c:formatCode>
                  <c:ptCount val="12"/>
                  <c:pt idx="0">
                    <c:v>0.38683572691789442</c:v>
                  </c:pt>
                  <c:pt idx="1">
                    <c:v>0.1637575278864194</c:v>
                  </c:pt>
                  <c:pt idx="2">
                    <c:v>0.23293269491950661</c:v>
                  </c:pt>
                  <c:pt idx="3">
                    <c:v>0.25848551106004719</c:v>
                  </c:pt>
                  <c:pt idx="4">
                    <c:v>0.16038701517168941</c:v>
                  </c:pt>
                  <c:pt idx="5">
                    <c:v>0.13287706947858635</c:v>
                  </c:pt>
                  <c:pt idx="6">
                    <c:v>0.17203765264582366</c:v>
                  </c:pt>
                  <c:pt idx="7">
                    <c:v>0.33310363174139285</c:v>
                  </c:pt>
                  <c:pt idx="8">
                    <c:v>0.3683048433048432</c:v>
                  </c:pt>
                  <c:pt idx="9">
                    <c:v>9.7079772079772031E-2</c:v>
                  </c:pt>
                  <c:pt idx="10">
                    <c:v>0</c:v>
                  </c:pt>
                  <c:pt idx="11">
                    <c:v>0.15111417296006036</c:v>
                  </c:pt>
                </c:numCache>
              </c:numRef>
            </c:minus>
          </c:errBars>
          <c:cat>
            <c:strRef>
              <c:f>'summary of 3'!$H$55:$H$66</c:f>
              <c:strCache>
                <c:ptCount val="12"/>
                <c:pt idx="0">
                  <c:v>-309</c:v>
                </c:pt>
                <c:pt idx="1">
                  <c:v>-280</c:v>
                </c:pt>
                <c:pt idx="2">
                  <c:v>-113</c:v>
                </c:pt>
                <c:pt idx="3">
                  <c:v>-86</c:v>
                </c:pt>
                <c:pt idx="4">
                  <c:v>-5</c:v>
                </c:pt>
                <c:pt idx="5">
                  <c:v>79</c:v>
                </c:pt>
                <c:pt idx="6">
                  <c:v>126</c:v>
                </c:pt>
                <c:pt idx="7">
                  <c:v>161</c:v>
                </c:pt>
                <c:pt idx="8">
                  <c:v>203</c:v>
                </c:pt>
                <c:pt idx="9">
                  <c:v>257</c:v>
                </c:pt>
                <c:pt idx="10">
                  <c:v>trcrRNA</c:v>
                </c:pt>
                <c:pt idx="11">
                  <c:v>mock</c:v>
                </c:pt>
              </c:strCache>
            </c:strRef>
          </c:cat>
          <c:val>
            <c:numRef>
              <c:f>'summary of 3'!$I$55:$I$66</c:f>
              <c:numCache>
                <c:formatCode>General</c:formatCode>
                <c:ptCount val="12"/>
                <c:pt idx="0">
                  <c:v>1.5681087064895456</c:v>
                </c:pt>
                <c:pt idx="1">
                  <c:v>1.3243892577027969</c:v>
                </c:pt>
                <c:pt idx="2">
                  <c:v>0.86505200614464262</c:v>
                </c:pt>
                <c:pt idx="3">
                  <c:v>1.3421718120154376</c:v>
                </c:pt>
                <c:pt idx="4">
                  <c:v>0.34144739721145106</c:v>
                </c:pt>
                <c:pt idx="5">
                  <c:v>0.5188051106103363</c:v>
                </c:pt>
                <c:pt idx="6">
                  <c:v>1.7855197681998947</c:v>
                </c:pt>
                <c:pt idx="7">
                  <c:v>0.71447125394472977</c:v>
                </c:pt>
                <c:pt idx="8">
                  <c:v>1.5705840455840459</c:v>
                </c:pt>
                <c:pt idx="9">
                  <c:v>1.2751424501424502</c:v>
                </c:pt>
                <c:pt idx="10">
                  <c:v>1</c:v>
                </c:pt>
                <c:pt idx="11">
                  <c:v>0.606241188505638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BA-4CB6-A7AD-CC0990512963}"/>
            </c:ext>
          </c:extLst>
        </c:ser>
        <c:ser>
          <c:idx val="1"/>
          <c:order val="1"/>
          <c:tx>
            <c:strRef>
              <c:f>'summary of 3'!$J$54</c:f>
              <c:strCache>
                <c:ptCount val="1"/>
                <c:pt idx="0">
                  <c:v>MFGE8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ummary of 3'!$L$55:$L$66</c:f>
                <c:numCache>
                  <c:formatCode>General</c:formatCode>
                  <c:ptCount val="12"/>
                  <c:pt idx="0">
                    <c:v>4.4851012961226691E-2</c:v>
                  </c:pt>
                  <c:pt idx="1">
                    <c:v>0.41072930160173088</c:v>
                  </c:pt>
                  <c:pt idx="2">
                    <c:v>1.0766161102391074</c:v>
                  </c:pt>
                  <c:pt idx="3">
                    <c:v>0.67383227368811138</c:v>
                  </c:pt>
                  <c:pt idx="4">
                    <c:v>0.91959289592743965</c:v>
                  </c:pt>
                  <c:pt idx="5">
                    <c:v>0.27491505906633029</c:v>
                  </c:pt>
                  <c:pt idx="6">
                    <c:v>0.53765522993028991</c:v>
                  </c:pt>
                  <c:pt idx="7">
                    <c:v>0.36261987187274225</c:v>
                  </c:pt>
                  <c:pt idx="8">
                    <c:v>0.29867138319193109</c:v>
                  </c:pt>
                  <c:pt idx="9">
                    <c:v>1.0526554764112441</c:v>
                  </c:pt>
                  <c:pt idx="10">
                    <c:v>0</c:v>
                  </c:pt>
                  <c:pt idx="11">
                    <c:v>0.25242449889376567</c:v>
                  </c:pt>
                </c:numCache>
              </c:numRef>
            </c:plus>
            <c:minus>
              <c:numRef>
                <c:f>'summary of 3'!$L$55:$L$66</c:f>
                <c:numCache>
                  <c:formatCode>General</c:formatCode>
                  <c:ptCount val="12"/>
                  <c:pt idx="0">
                    <c:v>4.4851012961226691E-2</c:v>
                  </c:pt>
                  <c:pt idx="1">
                    <c:v>0.41072930160173088</c:v>
                  </c:pt>
                  <c:pt idx="2">
                    <c:v>1.0766161102391074</c:v>
                  </c:pt>
                  <c:pt idx="3">
                    <c:v>0.67383227368811138</c:v>
                  </c:pt>
                  <c:pt idx="4">
                    <c:v>0.91959289592743965</c:v>
                  </c:pt>
                  <c:pt idx="5">
                    <c:v>0.27491505906633029</c:v>
                  </c:pt>
                  <c:pt idx="6">
                    <c:v>0.53765522993028991</c:v>
                  </c:pt>
                  <c:pt idx="7">
                    <c:v>0.36261987187274225</c:v>
                  </c:pt>
                  <c:pt idx="8">
                    <c:v>0.29867138319193109</c:v>
                  </c:pt>
                  <c:pt idx="9">
                    <c:v>1.0526554764112441</c:v>
                  </c:pt>
                  <c:pt idx="10">
                    <c:v>0</c:v>
                  </c:pt>
                  <c:pt idx="11">
                    <c:v>0.25242449889376567</c:v>
                  </c:pt>
                </c:numCache>
              </c:numRef>
            </c:minus>
          </c:errBars>
          <c:cat>
            <c:strRef>
              <c:f>'summary of 3'!$H$55:$H$66</c:f>
              <c:strCache>
                <c:ptCount val="12"/>
                <c:pt idx="0">
                  <c:v>-309</c:v>
                </c:pt>
                <c:pt idx="1">
                  <c:v>-280</c:v>
                </c:pt>
                <c:pt idx="2">
                  <c:v>-113</c:v>
                </c:pt>
                <c:pt idx="3">
                  <c:v>-86</c:v>
                </c:pt>
                <c:pt idx="4">
                  <c:v>-5</c:v>
                </c:pt>
                <c:pt idx="5">
                  <c:v>79</c:v>
                </c:pt>
                <c:pt idx="6">
                  <c:v>126</c:v>
                </c:pt>
                <c:pt idx="7">
                  <c:v>161</c:v>
                </c:pt>
                <c:pt idx="8">
                  <c:v>203</c:v>
                </c:pt>
                <c:pt idx="9">
                  <c:v>257</c:v>
                </c:pt>
                <c:pt idx="10">
                  <c:v>trcrRNA</c:v>
                </c:pt>
                <c:pt idx="11">
                  <c:v>mock</c:v>
                </c:pt>
              </c:strCache>
            </c:strRef>
          </c:cat>
          <c:val>
            <c:numRef>
              <c:f>'summary of 3'!$J$55:$J$66</c:f>
              <c:numCache>
                <c:formatCode>General</c:formatCode>
                <c:ptCount val="12"/>
                <c:pt idx="0">
                  <c:v>2.2720721725903652</c:v>
                </c:pt>
                <c:pt idx="1">
                  <c:v>2.562619803967904</c:v>
                </c:pt>
                <c:pt idx="2">
                  <c:v>6.6201154090087506</c:v>
                </c:pt>
                <c:pt idx="3">
                  <c:v>3.5972356550465974</c:v>
                </c:pt>
                <c:pt idx="4">
                  <c:v>1.9024179389511275</c:v>
                </c:pt>
                <c:pt idx="5">
                  <c:v>1.5231454136180329</c:v>
                </c:pt>
                <c:pt idx="6">
                  <c:v>1.4523556572977439</c:v>
                </c:pt>
                <c:pt idx="7">
                  <c:v>1.8378060447732834</c:v>
                </c:pt>
                <c:pt idx="8">
                  <c:v>1.0506369560918447</c:v>
                </c:pt>
                <c:pt idx="9">
                  <c:v>1.7656123249665339</c:v>
                </c:pt>
                <c:pt idx="10">
                  <c:v>1</c:v>
                </c:pt>
                <c:pt idx="11">
                  <c:v>0.538668398600518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7BA-4CB6-A7AD-CC09905129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6936832"/>
        <c:axId val="66938368"/>
      </c:barChart>
      <c:catAx>
        <c:axId val="669368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66938368"/>
        <c:crosses val="autoZero"/>
        <c:auto val="1"/>
        <c:lblAlgn val="ctr"/>
        <c:lblOffset val="100"/>
        <c:noMultiLvlLbl val="0"/>
      </c:catAx>
      <c:valAx>
        <c:axId val="669383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669368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34320412277922668"/>
          <c:y val="0.11917969321959693"/>
          <c:w val="0.15183349113597081"/>
          <c:h val="0.1950926791677924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4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 smtClean="0"/>
            </a:lvl1pPr>
          </a:lstStyle>
          <a:p>
            <a:pPr>
              <a:defRPr/>
            </a:pPr>
            <a:fld id="{1C9D0A36-DE4C-4440-8F6C-AEF2CA54FF85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 smtClean="0"/>
            </a:lvl1pPr>
          </a:lstStyle>
          <a:p>
            <a:pPr>
              <a:defRPr/>
            </a:pPr>
            <a:fld id="{A95C0E93-8D30-4A30-9328-4E0FB45E5BB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58131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A5558D-8F49-48AC-9AD1-376CB1A7E39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4AB339-7594-4B22-A554-7B400AD98A7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87302B-CA7A-4E6B-A47F-DC332C23FD1A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B45D9B-561E-4F88-9AB5-8E4B827DF60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3E4499-94DD-4CAD-8E21-EA1AF54156B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1531EF-E7B4-422A-88BB-47B0975638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5F7945-BBD4-4978-87EC-C7D80B463AB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82FDBD-73E8-482B-8B0A-795AAB09BF7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D2AAE2-0E64-4293-B29A-F50BD23856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6B7EBA-6E88-45F3-AFA7-7E4748CF9C5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A8DA1D-4DE8-42BC-BD9E-CD5459035D5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6093AD-FB35-44EB-A78B-A8D57029FF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262641-2E0D-4F47-A695-B40F164E5298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51291B-6319-4CBE-8716-8CDE732F976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FDA3E8-4DC9-49DD-84E5-CA89B17ADDB1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D8FBAA-AA12-4A4C-97FB-28969739D87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30EB80-9B42-4E8C-93AE-BFC21D3B5E8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D0E515-5FC4-4574-A5BE-D608BFDDD9D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B70ED7-D082-44C4-A6ED-5DA8752B74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DAFEFA-4281-4F12-A99A-44E264AE90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59D499-0483-4786-8C94-B4A7588B087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57DE42-43C2-45E9-BD3A-849BD950B3A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A6D2247-3288-4C0A-8C55-B2B65727C759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234A502B-99B5-4993-AC5A-918CFA4C90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1536918"/>
              </p:ext>
            </p:extLst>
          </p:nvPr>
        </p:nvGraphicFramePr>
        <p:xfrm>
          <a:off x="2539460" y="537515"/>
          <a:ext cx="5135219" cy="38298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3" name="Straight Connector 2"/>
          <p:cNvCxnSpPr/>
          <p:nvPr/>
        </p:nvCxnSpPr>
        <p:spPr>
          <a:xfrm>
            <a:off x="2744870" y="3267613"/>
            <a:ext cx="3909391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 rot="16200000">
            <a:off x="24672" y="2028414"/>
            <a:ext cx="41778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Relative expression </a:t>
            </a:r>
          </a:p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(normalized to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trcrRNA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875321" y="2607881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*</a:t>
            </a:r>
            <a:endParaRPr lang="en-CA" dirty="0"/>
          </a:p>
        </p:txBody>
      </p:sp>
      <p:sp>
        <p:nvSpPr>
          <p:cNvPr id="7" name="TextBox 6"/>
          <p:cNvSpPr txBox="1"/>
          <p:nvPr/>
        </p:nvSpPr>
        <p:spPr>
          <a:xfrm>
            <a:off x="3239523" y="2423215"/>
            <a:ext cx="3057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9" name="TextBox 8"/>
          <p:cNvSpPr txBox="1"/>
          <p:nvPr/>
        </p:nvSpPr>
        <p:spPr>
          <a:xfrm>
            <a:off x="3564318" y="861115"/>
            <a:ext cx="3057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10" name="TextBox 9"/>
          <p:cNvSpPr txBox="1"/>
          <p:nvPr/>
        </p:nvSpPr>
        <p:spPr>
          <a:xfrm>
            <a:off x="3870063" y="1940280"/>
            <a:ext cx="3057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11" name="Rectangle 10"/>
          <p:cNvSpPr/>
          <p:nvPr/>
        </p:nvSpPr>
        <p:spPr>
          <a:xfrm>
            <a:off x="1550784" y="4792586"/>
            <a:ext cx="6317226" cy="10833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auto">
              <a:lnSpc>
                <a:spcPct val="115000"/>
              </a:lnSpc>
              <a:spcAft>
                <a:spcPts val="1000"/>
              </a:spcAft>
            </a:pP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3 Fig. </a:t>
            </a:r>
            <a:r>
              <a:rPr lang="en-US" sz="1400" b="1" i="1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MFGE8</a:t>
            </a:r>
            <a:r>
              <a:rPr lang="en-US" sz="1400" b="1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400" b="1" kern="15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activation does not correlate with </a:t>
            </a:r>
            <a:r>
              <a:rPr lang="en-US" sz="1400" b="1" i="1" kern="15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IL6</a:t>
            </a:r>
            <a:r>
              <a:rPr lang="en-US" sz="1400" b="1" kern="15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 expression.  </a:t>
            </a:r>
            <a:r>
              <a:rPr lang="en-US" sz="1400" kern="150" dirty="0" err="1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CRISPRa</a:t>
            </a:r>
            <a:r>
              <a:rPr lang="en-US" sz="1400" kern="15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 targeting the </a:t>
            </a:r>
            <a:r>
              <a:rPr lang="en-US" sz="1400" i="1" kern="15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MFGE8</a:t>
            </a:r>
            <a:r>
              <a:rPr lang="en-US" sz="1400" kern="15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 promoter region in HEK293T cells.  Numbers refer to position of </a:t>
            </a:r>
            <a:r>
              <a:rPr lang="en-US" sz="1400" kern="150" dirty="0" err="1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sgRNA</a:t>
            </a:r>
            <a:r>
              <a:rPr lang="en-US" sz="1400" kern="15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 cognate site relative to start site (</a:t>
            </a:r>
            <a:r>
              <a:rPr lang="en-US" sz="1400" kern="150" dirty="0" err="1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RefSeq</a:t>
            </a:r>
            <a:r>
              <a:rPr lang="en-US" sz="1400" kern="15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: NM_001114614). Data represent the average of 3 experiments (± S.D.)</a:t>
            </a:r>
            <a:endParaRPr lang="en-CA" sz="1400" kern="150" dirty="0">
              <a:effectLst/>
              <a:latin typeface="Liberation Serif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00267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931</TotalTime>
  <Words>60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Liberation Serif</vt:lpstr>
      <vt:lpstr>Times New Roman</vt:lpstr>
      <vt:lpstr>Office Theme</vt:lpstr>
      <vt:lpstr>PowerPoint Presentation</vt:lpstr>
    </vt:vector>
  </TitlesOfParts>
  <Company>UOH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soubeyrand</dc:creator>
  <cp:lastModifiedBy>Sebastien Soubeyrand</cp:lastModifiedBy>
  <cp:revision>1210</cp:revision>
  <dcterms:created xsi:type="dcterms:W3CDTF">2017-11-23T16:07:42Z</dcterms:created>
  <dcterms:modified xsi:type="dcterms:W3CDTF">2019-10-09T12:48:22Z</dcterms:modified>
</cp:coreProperties>
</file>